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-3352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50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39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050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238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376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077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833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34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961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64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732AC-0F5D-EA4E-81A8-2D7699DBB53A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76E88-203D-6B45-B450-2F9703F885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909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79914" y="381680"/>
            <a:ext cx="2930911" cy="2937999"/>
            <a:chOff x="3722537" y="291549"/>
            <a:chExt cx="2930911" cy="2937999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22537" y="291549"/>
              <a:ext cx="2930911" cy="2937999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059998" y="2154470"/>
              <a:ext cx="14418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XII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240442" y="519983"/>
              <a:ext cx="505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asal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5302592" y="1637731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pSp>
        <p:nvGrpSpPr>
          <p:cNvPr id="9" name="Group 8"/>
          <p:cNvGrpSpPr/>
          <p:nvPr/>
        </p:nvGrpSpPr>
        <p:grpSpPr>
          <a:xfrm>
            <a:off x="3452482" y="381680"/>
            <a:ext cx="2917019" cy="2938600"/>
            <a:chOff x="4472646" y="325975"/>
            <a:chExt cx="2917019" cy="293860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72646" y="325975"/>
              <a:ext cx="2917019" cy="29386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5006262" y="541227"/>
              <a:ext cx="5267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HER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818908" y="2192378"/>
              <a:ext cx="14418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XII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406145" y="3708971"/>
            <a:ext cx="3004680" cy="2997483"/>
            <a:chOff x="606663" y="3304912"/>
            <a:chExt cx="3004680" cy="2997483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6663" y="3304912"/>
              <a:ext cx="3004680" cy="2997483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016471" y="5221993"/>
              <a:ext cx="14418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XII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339852" y="3548288"/>
              <a:ext cx="731587" cy="246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Luminal A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3432578" y="3787526"/>
            <a:ext cx="2936923" cy="2918928"/>
            <a:chOff x="2377270" y="3383467"/>
            <a:chExt cx="2936923" cy="2918928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77270" y="3383467"/>
              <a:ext cx="2936923" cy="2918928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3011011" y="3560633"/>
              <a:ext cx="685553" cy="2268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Luminal B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743771" y="5240370"/>
              <a:ext cx="14418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XII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436527" y="155639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A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325581" y="147383"/>
            <a:ext cx="432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B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31025" y="3531198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C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325581" y="3537820"/>
            <a:ext cx="369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D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80328" y="8753502"/>
            <a:ext cx="8772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2 Fig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721848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rost</dc:creator>
  <cp:lastModifiedBy>Susan Frost</cp:lastModifiedBy>
  <cp:revision>1</cp:revision>
  <dcterms:created xsi:type="dcterms:W3CDTF">2018-06-13T18:13:25Z</dcterms:created>
  <dcterms:modified xsi:type="dcterms:W3CDTF">2018-06-13T18:14:03Z</dcterms:modified>
</cp:coreProperties>
</file>